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B7CF2-E270-4DD1-8413-BBBE9402B3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41C82-B6F0-430D-8804-CC413F3768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E5951-7430-44B6-B463-EB933E1A0E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D818F-D462-4B72-9CCF-DA369E09CF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23279-DD5F-49B8-94EA-4E98AF741C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65F64-7201-4816-9B69-1435ABF60B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B20EA-22E2-4DA4-98F7-3A5722C981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FEAA6-5217-4809-ADA2-6291DDCF9A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E86CD1-41F7-4513-A3E1-0419A1E8DC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4706A-91FF-4D05-B4F3-C18411BD94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AE891-D5B9-4A63-8AC8-FDCA9B7AA3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E0CDB-DBC7-49B5-895B-FAD6EE31E2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4FED7D-6832-42B9-AE08-0347CB9DDEA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3-11-09 Cefas1"/>
          <p:cNvPicPr/>
          <p:nvPr/>
        </p:nvPicPr>
        <p:blipFill>
          <a:blip r:embed="rId1"/>
          <a:srcRect l="0" t="20008" r="13715" b="42779"/>
          <a:stretch/>
        </p:blipFill>
        <p:spPr>
          <a:xfrm>
            <a:off x="1523880" y="1905120"/>
            <a:ext cx="5391360" cy="1371600"/>
          </a:xfrm>
          <a:prstGeom prst="rect">
            <a:avLst/>
          </a:prstGeom>
          <a:ln w="0">
            <a:noFill/>
          </a:ln>
        </p:spPr>
      </p:pic>
      <p:sp>
        <p:nvSpPr>
          <p:cNvPr id="42" name="TextBox 13"/>
          <p:cNvSpPr/>
          <p:nvPr/>
        </p:nvSpPr>
        <p:spPr>
          <a:xfrm>
            <a:off x="371628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27"/>
          <p:cNvSpPr/>
          <p:nvPr/>
        </p:nvSpPr>
        <p:spPr>
          <a:xfrm>
            <a:off x="393048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28"/>
          <p:cNvSpPr/>
          <p:nvPr/>
        </p:nvSpPr>
        <p:spPr>
          <a:xfrm>
            <a:off x="4145040" y="1765440"/>
            <a:ext cx="30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29"/>
          <p:cNvSpPr/>
          <p:nvPr/>
        </p:nvSpPr>
        <p:spPr>
          <a:xfrm>
            <a:off x="435924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30"/>
          <p:cNvSpPr/>
          <p:nvPr/>
        </p:nvSpPr>
        <p:spPr>
          <a:xfrm>
            <a:off x="4575240" y="1765440"/>
            <a:ext cx="30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31"/>
          <p:cNvSpPr/>
          <p:nvPr/>
        </p:nvSpPr>
        <p:spPr>
          <a:xfrm>
            <a:off x="478944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32"/>
          <p:cNvSpPr/>
          <p:nvPr/>
        </p:nvSpPr>
        <p:spPr>
          <a:xfrm>
            <a:off x="500364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33"/>
          <p:cNvSpPr/>
          <p:nvPr/>
        </p:nvSpPr>
        <p:spPr>
          <a:xfrm>
            <a:off x="5218200" y="1765440"/>
            <a:ext cx="30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34"/>
          <p:cNvSpPr/>
          <p:nvPr/>
        </p:nvSpPr>
        <p:spPr>
          <a:xfrm>
            <a:off x="543240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35"/>
          <p:cNvSpPr/>
          <p:nvPr/>
        </p:nvSpPr>
        <p:spPr>
          <a:xfrm>
            <a:off x="564660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36"/>
          <p:cNvSpPr/>
          <p:nvPr/>
        </p:nvSpPr>
        <p:spPr>
          <a:xfrm>
            <a:off x="586260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37"/>
          <p:cNvSpPr/>
          <p:nvPr/>
        </p:nvSpPr>
        <p:spPr>
          <a:xfrm>
            <a:off x="607680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38"/>
          <p:cNvSpPr/>
          <p:nvPr/>
        </p:nvSpPr>
        <p:spPr>
          <a:xfrm>
            <a:off x="6291360" y="1765440"/>
            <a:ext cx="30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9"/>
          <p:cNvSpPr/>
          <p:nvPr/>
        </p:nvSpPr>
        <p:spPr>
          <a:xfrm>
            <a:off x="650556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3"/>
          <p:cNvSpPr/>
          <p:nvPr/>
        </p:nvSpPr>
        <p:spPr>
          <a:xfrm>
            <a:off x="350208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3"/>
          <p:cNvSpPr/>
          <p:nvPr/>
        </p:nvSpPr>
        <p:spPr>
          <a:xfrm>
            <a:off x="178596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3"/>
          <p:cNvSpPr/>
          <p:nvPr/>
        </p:nvSpPr>
        <p:spPr>
          <a:xfrm>
            <a:off x="3287880" y="1765440"/>
            <a:ext cx="30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3"/>
          <p:cNvSpPr/>
          <p:nvPr/>
        </p:nvSpPr>
        <p:spPr>
          <a:xfrm>
            <a:off x="264312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3"/>
          <p:cNvSpPr/>
          <p:nvPr/>
        </p:nvSpPr>
        <p:spPr>
          <a:xfrm>
            <a:off x="307332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3"/>
          <p:cNvSpPr/>
          <p:nvPr/>
        </p:nvSpPr>
        <p:spPr>
          <a:xfrm>
            <a:off x="242892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3"/>
          <p:cNvSpPr/>
          <p:nvPr/>
        </p:nvSpPr>
        <p:spPr>
          <a:xfrm>
            <a:off x="2857680" y="1765440"/>
            <a:ext cx="30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3"/>
          <p:cNvSpPr/>
          <p:nvPr/>
        </p:nvSpPr>
        <p:spPr>
          <a:xfrm>
            <a:off x="2000160" y="176544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3"/>
          <p:cNvSpPr/>
          <p:nvPr/>
        </p:nvSpPr>
        <p:spPr>
          <a:xfrm>
            <a:off x="2214720" y="1765440"/>
            <a:ext cx="30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858000" y="24843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858720" y="237636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lo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858000" y="27273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858000" y="2619360"/>
            <a:ext cx="48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IncA/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6858000" y="29415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6858360" y="2833560"/>
            <a:ext cx="38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Inc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57200" y="2697480"/>
            <a:ext cx="8077320" cy="347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141200" rIns="1141200" tIns="914040" bIns="9140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Lane 2, p33A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lo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ontaining IncN plasmid); lane 3, PCR negative control; lane 4, strain 08016; lane 5, 08019; lane 6, 08024; lane 7, 08029; lane 8, 08028; lane 9, 08029; lane 10, 08034; lane 11, 08054; lane 12, 08056; lane 13, 08057; lane 14, 08059; lane 15,  08060; lane 16, 08061; lane 17, 08075; lane 18, 08079; lane 19, 08080; lane 20, blank; lane 21, 08045; lane 22, 08020; lane 23, 08067. MW marker GeneRuler 100 bp PlusDNA Ladder (Fermentas). Position of floR, IncA/C and IncN amplicons is designate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V00</cp:lastModifiedBy>
  <dcterms:modified xsi:type="dcterms:W3CDTF">2009-11-25T10:56:29Z</dcterms:modified>
  <cp:revision>1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